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D6AF3-6A73-4EE5-A0CD-C2C66A2DC9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CF76D5-02B5-4988-A07B-984805AC3C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86491-E364-49D3-B0BA-F8607D0505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D35A5-3918-4033-9BFD-7D67B2E91D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0B744-FCAB-4D69-8700-511EAE67D8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D3AAA-45F9-4964-98B2-A627B70B4F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67895-C238-41D3-855F-9DE86A5DDA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44EA9-233F-4910-9E9C-AA6D20A1C5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D8D49-09BD-4171-A7EB-B3E15364D3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2F1D5-5710-4D81-A943-66127AD5D1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6DC18-1097-4BEE-863D-D3CE87AA48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F8260-0201-4BFA-98AD-71B411397D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AD4E738-C498-4F7D-8863-D1F95319AD94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7CE1E97-0EFD-46F3-B898-D9E2CBB060A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2060640" y="950760"/>
            <a:ext cx="5108400" cy="3591000"/>
          </a:xfrm>
          <a:prstGeom prst="rect">
            <a:avLst/>
          </a:prstGeom>
          <a:ln w="0">
            <a:noFill/>
          </a:ln>
        </p:spPr>
      </p:pic>
      <p:sp>
        <p:nvSpPr>
          <p:cNvPr id="42" name="正方形/長方形 6"/>
          <p:cNvSpPr/>
          <p:nvPr/>
        </p:nvSpPr>
        <p:spPr>
          <a:xfrm>
            <a:off x="1968480" y="4581360"/>
            <a:ext cx="522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gure S1  Distribution of extracted tag lengt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正方形/長方形 5"/>
          <p:cNvSpPr/>
          <p:nvPr/>
        </p:nvSpPr>
        <p:spPr>
          <a:xfrm>
            <a:off x="2068560" y="5111640"/>
            <a:ext cx="4878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ags were extracted from sequence reads of sample, and number of total and unique  tags from 26 to 31 bases were estimated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19T00:31:36Z</dcterms:created>
  <dc:creator>松村 英生</dc:creator>
  <dc:description/>
  <dc:language>en-US</dc:language>
  <cp:lastModifiedBy>松村 英生</cp:lastModifiedBy>
  <dcterms:modified xsi:type="dcterms:W3CDTF">2010-02-19T00:31:54Z</dcterms:modified>
  <cp:revision>1</cp:revision>
  <dc:subject/>
  <dc:title>スライド 1</dc:title>
</cp:coreProperties>
</file>